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 showGuides="1">
      <p:cViewPr varScale="1">
        <p:scale>
          <a:sx n="56" d="100"/>
          <a:sy n="56" d="100"/>
        </p:scale>
        <p:origin x="-2400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ack%20Up%20Shelby:Users:montagues:Documents:Baker%20Lab:Courtship%20Conditioning:spreadsheets:MBScreen_Analysis_6July2015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Back%20Up%20Shelby:Users:montagues:Documents:Baker%20Lab:MB%20Mini-Olympiad:MBScreen_Analysis_26Jun201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0288081315028"/>
          <c:y val="0.0592201166180758"/>
          <c:w val="0.876671483120519"/>
          <c:h val="0.721968546980097"/>
        </c:manualLayout>
      </c:layout>
      <c:barChart>
        <c:barDir val="col"/>
        <c:grouping val="clustered"/>
        <c:varyColors val="0"/>
        <c:ser>
          <c:idx val="0"/>
          <c:order val="0"/>
          <c:tx>
            <c:v>CIbegin</c:v>
          </c:tx>
          <c:spPr>
            <a:solidFill>
              <a:srgbClr val="FF0000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NewSecondaryCharts_22May15!$K$30:$K$41</c:f>
                <c:numCache>
                  <c:formatCode>General</c:formatCode>
                  <c:ptCount val="12"/>
                  <c:pt idx="0">
                    <c:v>0.0638980210428518</c:v>
                  </c:pt>
                  <c:pt idx="1">
                    <c:v>0.0306067912064684</c:v>
                  </c:pt>
                  <c:pt idx="2">
                    <c:v>0.028141718</c:v>
                  </c:pt>
                  <c:pt idx="4">
                    <c:v>0.0263341965089348</c:v>
                  </c:pt>
                  <c:pt idx="5">
                    <c:v>0.0122310353463083</c:v>
                  </c:pt>
                  <c:pt idx="7">
                    <c:v>0.0267089547379067</c:v>
                  </c:pt>
                  <c:pt idx="8">
                    <c:v>0.0527325630679317</c:v>
                  </c:pt>
                  <c:pt idx="10">
                    <c:v>0.00938546815224838</c:v>
                  </c:pt>
                  <c:pt idx="11">
                    <c:v>0.05095175045782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SecondaryCharts_22May15!$F$30:$F$41</c:f>
              <c:strCache>
                <c:ptCount val="12"/>
                <c:pt idx="0">
                  <c:v>MB051C</c:v>
                </c:pt>
                <c:pt idx="1">
                  <c:v>MB077C</c:v>
                </c:pt>
                <c:pt idx="2">
                  <c:v>MB018B</c:v>
                </c:pt>
                <c:pt idx="4">
                  <c:v>MB011B</c:v>
                </c:pt>
                <c:pt idx="5">
                  <c:v>MB210B</c:v>
                </c:pt>
                <c:pt idx="7">
                  <c:v>MB083C</c:v>
                </c:pt>
                <c:pt idx="8">
                  <c:v>MB110C</c:v>
                </c:pt>
                <c:pt idx="10">
                  <c:v>MB310C</c:v>
                </c:pt>
                <c:pt idx="11">
                  <c:v>MB323B</c:v>
                </c:pt>
              </c:strCache>
            </c:strRef>
          </c:cat>
          <c:val>
            <c:numRef>
              <c:f>NewSecondaryCharts_22May15!$G$30:$G$41</c:f>
              <c:numCache>
                <c:formatCode>General</c:formatCode>
                <c:ptCount val="12"/>
                <c:pt idx="0">
                  <c:v>0.101067037037037</c:v>
                </c:pt>
                <c:pt idx="1">
                  <c:v>0.05674</c:v>
                </c:pt>
                <c:pt idx="2">
                  <c:v>0.135579804</c:v>
                </c:pt>
                <c:pt idx="4">
                  <c:v>0.471523923858966</c:v>
                </c:pt>
                <c:pt idx="5">
                  <c:v>0.327895169082126</c:v>
                </c:pt>
                <c:pt idx="7">
                  <c:v>0.075944375</c:v>
                </c:pt>
                <c:pt idx="8">
                  <c:v>0.0992203125</c:v>
                </c:pt>
                <c:pt idx="10">
                  <c:v>0.0325141666666667</c:v>
                </c:pt>
                <c:pt idx="11">
                  <c:v>0.193837803030303</c:v>
                </c:pt>
              </c:numCache>
            </c:numRef>
          </c:val>
        </c:ser>
        <c:ser>
          <c:idx val="1"/>
          <c:order val="1"/>
          <c:tx>
            <c:v>CIend</c:v>
          </c:tx>
          <c:spPr>
            <a:solidFill>
              <a:srgbClr val="0000FF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NewSecondaryCharts_22May15!$L$30:$L$41</c:f>
                <c:numCache>
                  <c:formatCode>General</c:formatCode>
                  <c:ptCount val="12"/>
                  <c:pt idx="0">
                    <c:v>0.004419082711333</c:v>
                  </c:pt>
                  <c:pt idx="1">
                    <c:v>0.0</c:v>
                  </c:pt>
                  <c:pt idx="2">
                    <c:v>0.005654868</c:v>
                  </c:pt>
                  <c:pt idx="4">
                    <c:v>0.0239522754709713</c:v>
                  </c:pt>
                  <c:pt idx="5">
                    <c:v>0.00909701420546541</c:v>
                  </c:pt>
                  <c:pt idx="7">
                    <c:v>0.0</c:v>
                  </c:pt>
                  <c:pt idx="8">
                    <c:v>0.000139166666666667</c:v>
                  </c:pt>
                  <c:pt idx="10">
                    <c:v>0.00331533273594704</c:v>
                  </c:pt>
                  <c:pt idx="11">
                    <c:v>0.0183229399675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SecondaryCharts_22May15!$F$30:$F$41</c:f>
              <c:strCache>
                <c:ptCount val="12"/>
                <c:pt idx="0">
                  <c:v>MB051C</c:v>
                </c:pt>
                <c:pt idx="1">
                  <c:v>MB077C</c:v>
                </c:pt>
                <c:pt idx="2">
                  <c:v>MB018B</c:v>
                </c:pt>
                <c:pt idx="4">
                  <c:v>MB011B</c:v>
                </c:pt>
                <c:pt idx="5">
                  <c:v>MB210B</c:v>
                </c:pt>
                <c:pt idx="7">
                  <c:v>MB083C</c:v>
                </c:pt>
                <c:pt idx="8">
                  <c:v>MB110C</c:v>
                </c:pt>
                <c:pt idx="10">
                  <c:v>MB310C</c:v>
                </c:pt>
                <c:pt idx="11">
                  <c:v>MB323B</c:v>
                </c:pt>
              </c:strCache>
            </c:strRef>
          </c:cat>
          <c:val>
            <c:numRef>
              <c:f>NewSecondaryCharts_22May15!$H$30:$H$41</c:f>
              <c:numCache>
                <c:formatCode>General</c:formatCode>
                <c:ptCount val="12"/>
                <c:pt idx="0">
                  <c:v>0.00820481481481481</c:v>
                </c:pt>
                <c:pt idx="1">
                  <c:v>0.0</c:v>
                </c:pt>
                <c:pt idx="2">
                  <c:v>0.006886667</c:v>
                </c:pt>
                <c:pt idx="4">
                  <c:v>0.229143333333333</c:v>
                </c:pt>
                <c:pt idx="5">
                  <c:v>0.232557439613527</c:v>
                </c:pt>
                <c:pt idx="7">
                  <c:v>0.0</c:v>
                </c:pt>
                <c:pt idx="8">
                  <c:v>0.000139166666666667</c:v>
                </c:pt>
                <c:pt idx="10">
                  <c:v>0.00461291666666667</c:v>
                </c:pt>
                <c:pt idx="11">
                  <c:v>0.0380864393939394</c:v>
                </c:pt>
              </c:numCache>
            </c:numRef>
          </c:val>
        </c:ser>
        <c:ser>
          <c:idx val="2"/>
          <c:order val="2"/>
          <c:tx>
            <c:v>CItest</c:v>
          </c:tx>
          <c:spPr>
            <a:solidFill>
              <a:srgbClr val="FFFF00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NewSecondaryCharts_22May15!$M$30:$M$41</c:f>
                <c:numCache>
                  <c:formatCode>General</c:formatCode>
                  <c:ptCount val="12"/>
                  <c:pt idx="0">
                    <c:v>0.0752918351847119</c:v>
                  </c:pt>
                  <c:pt idx="1">
                    <c:v>0.0628985503541261</c:v>
                  </c:pt>
                  <c:pt idx="2">
                    <c:v>0.079594894</c:v>
                  </c:pt>
                  <c:pt idx="4">
                    <c:v>0.0480515917460693</c:v>
                  </c:pt>
                  <c:pt idx="5">
                    <c:v>0.0282413453460769</c:v>
                  </c:pt>
                  <c:pt idx="7">
                    <c:v>0.0144028549480029</c:v>
                  </c:pt>
                  <c:pt idx="8">
                    <c:v>0.0687227813739635</c:v>
                  </c:pt>
                  <c:pt idx="10">
                    <c:v>0.107947793448642</c:v>
                  </c:pt>
                  <c:pt idx="11">
                    <c:v>0.08269296229001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SecondaryCharts_22May15!$F$30:$F$41</c:f>
              <c:strCache>
                <c:ptCount val="12"/>
                <c:pt idx="0">
                  <c:v>MB051C</c:v>
                </c:pt>
                <c:pt idx="1">
                  <c:v>MB077C</c:v>
                </c:pt>
                <c:pt idx="2">
                  <c:v>MB018B</c:v>
                </c:pt>
                <c:pt idx="4">
                  <c:v>MB011B</c:v>
                </c:pt>
                <c:pt idx="5">
                  <c:v>MB210B</c:v>
                </c:pt>
                <c:pt idx="7">
                  <c:v>MB083C</c:v>
                </c:pt>
                <c:pt idx="8">
                  <c:v>MB110C</c:v>
                </c:pt>
                <c:pt idx="10">
                  <c:v>MB310C</c:v>
                </c:pt>
                <c:pt idx="11">
                  <c:v>MB323B</c:v>
                </c:pt>
              </c:strCache>
            </c:strRef>
          </c:cat>
          <c:val>
            <c:numRef>
              <c:f>NewSecondaryCharts_22May15!$I$30:$I$41</c:f>
              <c:numCache>
                <c:formatCode>General</c:formatCode>
                <c:ptCount val="12"/>
                <c:pt idx="0">
                  <c:v>0.179459814814815</c:v>
                </c:pt>
                <c:pt idx="1">
                  <c:v>0.086703125</c:v>
                </c:pt>
                <c:pt idx="2">
                  <c:v>0.383210686</c:v>
                </c:pt>
                <c:pt idx="4">
                  <c:v>0.542297040882544</c:v>
                </c:pt>
                <c:pt idx="5">
                  <c:v>0.534297577189666</c:v>
                </c:pt>
                <c:pt idx="7">
                  <c:v>0.0177063541666667</c:v>
                </c:pt>
                <c:pt idx="8">
                  <c:v>0.126566979166667</c:v>
                </c:pt>
                <c:pt idx="10">
                  <c:v>0.471926388888889</c:v>
                </c:pt>
                <c:pt idx="11">
                  <c:v>0.4750823484848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87510392"/>
        <c:axId val="-2103535144"/>
      </c:barChart>
      <c:catAx>
        <c:axId val="-2087510392"/>
        <c:scaling>
          <c:orientation val="minMax"/>
        </c:scaling>
        <c:delete val="0"/>
        <c:axPos val="b"/>
        <c:majorTickMark val="out"/>
        <c:minorTickMark val="none"/>
        <c:tickLblPos val="low"/>
        <c:txPr>
          <a:bodyPr rot="-5400000" vert="horz"/>
          <a:lstStyle/>
          <a:p>
            <a:pPr>
              <a:defRPr/>
            </a:pPr>
            <a:endParaRPr lang="en-US"/>
          </a:p>
        </c:txPr>
        <c:crossAx val="-2103535144"/>
        <c:crosses val="autoZero"/>
        <c:auto val="1"/>
        <c:lblAlgn val="ctr"/>
        <c:lblOffset val="100"/>
        <c:noMultiLvlLbl val="0"/>
      </c:catAx>
      <c:valAx>
        <c:axId val="-210353514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ourtship index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8751039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20268332344375"/>
          <c:y val="0.0777343839673102"/>
          <c:w val="0.113489724646806"/>
          <c:h val="0.240034821344543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0122890644154"/>
          <c:y val="0.0592703961423624"/>
          <c:w val="0.867308320358829"/>
          <c:h val="0.72039414992933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BON_26Jun15!$B$1</c:f>
              <c:strCache>
                <c:ptCount val="1"/>
                <c:pt idx="0">
                  <c:v>begin</c:v>
                </c:pt>
              </c:strCache>
            </c:strRef>
          </c:tx>
          <c:spPr>
            <a:solidFill>
              <a:srgbClr val="FF0000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BON_26Jun15!$F$2:$F$26</c:f>
                <c:numCache>
                  <c:formatCode>General</c:formatCode>
                  <c:ptCount val="25"/>
                  <c:pt idx="0">
                    <c:v>0.0321020690601592</c:v>
                  </c:pt>
                  <c:pt idx="1">
                    <c:v>0.0608519669473129</c:v>
                  </c:pt>
                  <c:pt idx="2">
                    <c:v>0.0599948545440224</c:v>
                  </c:pt>
                  <c:pt idx="3">
                    <c:v>0.0624073650613441</c:v>
                  </c:pt>
                  <c:pt idx="4">
                    <c:v>0.0599293909993556</c:v>
                  </c:pt>
                  <c:pt idx="5">
                    <c:v>0.0398532695220177</c:v>
                  </c:pt>
                  <c:pt idx="6">
                    <c:v>0.0923003248961016</c:v>
                  </c:pt>
                  <c:pt idx="7">
                    <c:v>0.0452681338950913</c:v>
                  </c:pt>
                  <c:pt idx="8">
                    <c:v>0.0540581588103516</c:v>
                  </c:pt>
                  <c:pt idx="9">
                    <c:v>0.0605567403010943</c:v>
                  </c:pt>
                  <c:pt idx="10">
                    <c:v>0.0524757914231175</c:v>
                  </c:pt>
                  <c:pt idx="11">
                    <c:v>0.0614285606955656</c:v>
                  </c:pt>
                  <c:pt idx="12">
                    <c:v>0.0676134747556117</c:v>
                  </c:pt>
                  <c:pt idx="13">
                    <c:v>0.0781769178319495</c:v>
                  </c:pt>
                  <c:pt idx="14">
                    <c:v>0.0554584817556242</c:v>
                  </c:pt>
                  <c:pt idx="15">
                    <c:v>0.0769109586692243</c:v>
                  </c:pt>
                  <c:pt idx="16">
                    <c:v>0.0579727682720851</c:v>
                  </c:pt>
                  <c:pt idx="17">
                    <c:v>0.0530566985469958</c:v>
                  </c:pt>
                  <c:pt idx="18">
                    <c:v>0.0596348650055415</c:v>
                  </c:pt>
                  <c:pt idx="19">
                    <c:v>0.0810496234708097</c:v>
                  </c:pt>
                  <c:pt idx="20">
                    <c:v>0.0425040319424979</c:v>
                  </c:pt>
                  <c:pt idx="21">
                    <c:v>0.0667871254345317</c:v>
                  </c:pt>
                  <c:pt idx="22">
                    <c:v>0.0514854731024368</c:v>
                  </c:pt>
                  <c:pt idx="23">
                    <c:v>0.0369142639666532</c:v>
                  </c:pt>
                  <c:pt idx="24">
                    <c:v>0.054649346421989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MBON_26Jun15!$A$2:$A$26</c:f>
              <c:strCache>
                <c:ptCount val="25"/>
                <c:pt idx="0">
                  <c:v>MB051B</c:v>
                </c:pt>
                <c:pt idx="1">
                  <c:v>MB077B</c:v>
                </c:pt>
                <c:pt idx="2">
                  <c:v>MB018B</c:v>
                </c:pt>
                <c:pt idx="3">
                  <c:v>MB011B</c:v>
                </c:pt>
                <c:pt idx="4">
                  <c:v>MB210B</c:v>
                </c:pt>
                <c:pt idx="5">
                  <c:v>MB002B</c:v>
                </c:pt>
                <c:pt idx="6">
                  <c:v>MB083C</c:v>
                </c:pt>
                <c:pt idx="7">
                  <c:v>MB310C</c:v>
                </c:pt>
                <c:pt idx="8">
                  <c:v>MB057B</c:v>
                </c:pt>
                <c:pt idx="9">
                  <c:v>MB549C</c:v>
                </c:pt>
                <c:pt idx="10">
                  <c:v>MB543B</c:v>
                </c:pt>
                <c:pt idx="11">
                  <c:v>MB027B</c:v>
                </c:pt>
                <c:pt idx="12">
                  <c:v>MB242A</c:v>
                </c:pt>
                <c:pt idx="13">
                  <c:v>MB093C</c:v>
                </c:pt>
                <c:pt idx="14">
                  <c:v>MB082C</c:v>
                </c:pt>
                <c:pt idx="15">
                  <c:v>MB074C</c:v>
                </c:pt>
                <c:pt idx="16">
                  <c:v>MB399B</c:v>
                </c:pt>
                <c:pt idx="17">
                  <c:v>MB080C</c:v>
                </c:pt>
                <c:pt idx="18">
                  <c:v>MB052B</c:v>
                </c:pt>
                <c:pt idx="19">
                  <c:v>MB050B</c:v>
                </c:pt>
                <c:pt idx="20">
                  <c:v>MB542B</c:v>
                </c:pt>
                <c:pt idx="21">
                  <c:v>MB112C</c:v>
                </c:pt>
                <c:pt idx="22">
                  <c:v>MB298B</c:v>
                </c:pt>
                <c:pt idx="23">
                  <c:v>MB434B</c:v>
                </c:pt>
                <c:pt idx="24">
                  <c:v>MB433B</c:v>
                </c:pt>
              </c:strCache>
            </c:strRef>
          </c:cat>
          <c:val>
            <c:numRef>
              <c:f>MBON_26Jun15!$B$2:$B$26</c:f>
              <c:numCache>
                <c:formatCode>General</c:formatCode>
                <c:ptCount val="25"/>
                <c:pt idx="0">
                  <c:v>0.187700869565217</c:v>
                </c:pt>
                <c:pt idx="1">
                  <c:v>0.208258636363636</c:v>
                </c:pt>
                <c:pt idx="2">
                  <c:v>0.176621916666667</c:v>
                </c:pt>
                <c:pt idx="3">
                  <c:v>0.577483333333333</c:v>
                </c:pt>
                <c:pt idx="4">
                  <c:v>0.369339275362319</c:v>
                </c:pt>
                <c:pt idx="5">
                  <c:v>0.13717115942029</c:v>
                </c:pt>
                <c:pt idx="6">
                  <c:v>0.16011</c:v>
                </c:pt>
                <c:pt idx="7">
                  <c:v>0.124352333333333</c:v>
                </c:pt>
                <c:pt idx="8">
                  <c:v>0.303439393939394</c:v>
                </c:pt>
                <c:pt idx="9">
                  <c:v>0.130395666666667</c:v>
                </c:pt>
                <c:pt idx="10">
                  <c:v>0.199817575757576</c:v>
                </c:pt>
                <c:pt idx="11">
                  <c:v>0.293455833333333</c:v>
                </c:pt>
                <c:pt idx="12">
                  <c:v>0.345036527777778</c:v>
                </c:pt>
                <c:pt idx="13">
                  <c:v>0.255667407407407</c:v>
                </c:pt>
                <c:pt idx="14">
                  <c:v>0.190398947368421</c:v>
                </c:pt>
                <c:pt idx="15">
                  <c:v>0.362025</c:v>
                </c:pt>
                <c:pt idx="16">
                  <c:v>0.338061590909091</c:v>
                </c:pt>
                <c:pt idx="17">
                  <c:v>0.0819718333333333</c:v>
                </c:pt>
                <c:pt idx="18">
                  <c:v>0.295553083333333</c:v>
                </c:pt>
                <c:pt idx="19">
                  <c:v>0.239371794871795</c:v>
                </c:pt>
                <c:pt idx="20">
                  <c:v>0.17619196969697</c:v>
                </c:pt>
                <c:pt idx="21">
                  <c:v>0.25084375</c:v>
                </c:pt>
                <c:pt idx="22">
                  <c:v>0.307296862745098</c:v>
                </c:pt>
                <c:pt idx="23">
                  <c:v>0.14833847826087</c:v>
                </c:pt>
                <c:pt idx="24">
                  <c:v>0.316002063492063</c:v>
                </c:pt>
              </c:numCache>
            </c:numRef>
          </c:val>
        </c:ser>
        <c:ser>
          <c:idx val="1"/>
          <c:order val="1"/>
          <c:tx>
            <c:strRef>
              <c:f>MBON_26Jun15!$C$1</c:f>
              <c:strCache>
                <c:ptCount val="1"/>
                <c:pt idx="0">
                  <c:v>end</c:v>
                </c:pt>
              </c:strCache>
            </c:strRef>
          </c:tx>
          <c:spPr>
            <a:solidFill>
              <a:srgbClr val="0000FF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BON_26Jun15!$G$2:$G$26</c:f>
                <c:numCache>
                  <c:formatCode>General</c:formatCode>
                  <c:ptCount val="25"/>
                  <c:pt idx="0">
                    <c:v>0.0183538313168548</c:v>
                  </c:pt>
                  <c:pt idx="1">
                    <c:v>0.011413578480656</c:v>
                  </c:pt>
                  <c:pt idx="2">
                    <c:v>0.0183868720724674</c:v>
                  </c:pt>
                  <c:pt idx="3">
                    <c:v>0.0506066654903896</c:v>
                  </c:pt>
                  <c:pt idx="4">
                    <c:v>0.0518923435956967</c:v>
                  </c:pt>
                  <c:pt idx="5">
                    <c:v>0.0165668602147848</c:v>
                  </c:pt>
                  <c:pt idx="6">
                    <c:v>0.00142631604812391</c:v>
                  </c:pt>
                  <c:pt idx="7">
                    <c:v>0.0413735751312275</c:v>
                  </c:pt>
                  <c:pt idx="8">
                    <c:v>0.0216363422246634</c:v>
                  </c:pt>
                  <c:pt idx="9">
                    <c:v>0.013885635381913</c:v>
                  </c:pt>
                  <c:pt idx="10">
                    <c:v>0.0386924597291322</c:v>
                  </c:pt>
                  <c:pt idx="11">
                    <c:v>0.00507934686291627</c:v>
                  </c:pt>
                  <c:pt idx="12">
                    <c:v>0.0452141583084175</c:v>
                  </c:pt>
                  <c:pt idx="13">
                    <c:v>0.052904643782135</c:v>
                  </c:pt>
                  <c:pt idx="14">
                    <c:v>0.0423041906804305</c:v>
                  </c:pt>
                  <c:pt idx="15">
                    <c:v>0.0609880830597582</c:v>
                  </c:pt>
                  <c:pt idx="16">
                    <c:v>0.0243615920081649</c:v>
                  </c:pt>
                  <c:pt idx="17">
                    <c:v>0.005831</c:v>
                  </c:pt>
                  <c:pt idx="18">
                    <c:v>0.0374137515828608</c:v>
                  </c:pt>
                  <c:pt idx="19">
                    <c:v>0.0753577125914033</c:v>
                  </c:pt>
                  <c:pt idx="20">
                    <c:v>0.0480802828402949</c:v>
                  </c:pt>
                  <c:pt idx="21">
                    <c:v>0.0481203730088619</c:v>
                  </c:pt>
                  <c:pt idx="22">
                    <c:v>0.0420828054177235</c:v>
                  </c:pt>
                  <c:pt idx="23">
                    <c:v>0.0419549301673673</c:v>
                  </c:pt>
                  <c:pt idx="24">
                    <c:v>0.052701708178758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MBON_26Jun15!$A$2:$A$26</c:f>
              <c:strCache>
                <c:ptCount val="25"/>
                <c:pt idx="0">
                  <c:v>MB051B</c:v>
                </c:pt>
                <c:pt idx="1">
                  <c:v>MB077B</c:v>
                </c:pt>
                <c:pt idx="2">
                  <c:v>MB018B</c:v>
                </c:pt>
                <c:pt idx="3">
                  <c:v>MB011B</c:v>
                </c:pt>
                <c:pt idx="4">
                  <c:v>MB210B</c:v>
                </c:pt>
                <c:pt idx="5">
                  <c:v>MB002B</c:v>
                </c:pt>
                <c:pt idx="6">
                  <c:v>MB083C</c:v>
                </c:pt>
                <c:pt idx="7">
                  <c:v>MB310C</c:v>
                </c:pt>
                <c:pt idx="8">
                  <c:v>MB057B</c:v>
                </c:pt>
                <c:pt idx="9">
                  <c:v>MB549C</c:v>
                </c:pt>
                <c:pt idx="10">
                  <c:v>MB543B</c:v>
                </c:pt>
                <c:pt idx="11">
                  <c:v>MB027B</c:v>
                </c:pt>
                <c:pt idx="12">
                  <c:v>MB242A</c:v>
                </c:pt>
                <c:pt idx="13">
                  <c:v>MB093C</c:v>
                </c:pt>
                <c:pt idx="14">
                  <c:v>MB082C</c:v>
                </c:pt>
                <c:pt idx="15">
                  <c:v>MB074C</c:v>
                </c:pt>
                <c:pt idx="16">
                  <c:v>MB399B</c:v>
                </c:pt>
                <c:pt idx="17">
                  <c:v>MB080C</c:v>
                </c:pt>
                <c:pt idx="18">
                  <c:v>MB052B</c:v>
                </c:pt>
                <c:pt idx="19">
                  <c:v>MB050B</c:v>
                </c:pt>
                <c:pt idx="20">
                  <c:v>MB542B</c:v>
                </c:pt>
                <c:pt idx="21">
                  <c:v>MB112C</c:v>
                </c:pt>
                <c:pt idx="22">
                  <c:v>MB298B</c:v>
                </c:pt>
                <c:pt idx="23">
                  <c:v>MB434B</c:v>
                </c:pt>
                <c:pt idx="24">
                  <c:v>MB433B</c:v>
                </c:pt>
              </c:strCache>
            </c:strRef>
          </c:cat>
          <c:val>
            <c:numRef>
              <c:f>MBON_26Jun15!$C$2:$C$26</c:f>
              <c:numCache>
                <c:formatCode>General</c:formatCode>
                <c:ptCount val="25"/>
                <c:pt idx="0">
                  <c:v>0.0390589130434782</c:v>
                </c:pt>
                <c:pt idx="1">
                  <c:v>0.0162457575757576</c:v>
                </c:pt>
                <c:pt idx="2">
                  <c:v>0.0349535833333333</c:v>
                </c:pt>
                <c:pt idx="3">
                  <c:v>0.181808260869565</c:v>
                </c:pt>
                <c:pt idx="4">
                  <c:v>0.256052753623188</c:v>
                </c:pt>
                <c:pt idx="5">
                  <c:v>0.0416276086956522</c:v>
                </c:pt>
                <c:pt idx="6">
                  <c:v>0.00201277777777778</c:v>
                </c:pt>
                <c:pt idx="7">
                  <c:v>0.0654234444444444</c:v>
                </c:pt>
                <c:pt idx="8">
                  <c:v>0.0374144696969697</c:v>
                </c:pt>
                <c:pt idx="9">
                  <c:v>0.0268851111111111</c:v>
                </c:pt>
                <c:pt idx="10">
                  <c:v>0.0689602272727273</c:v>
                </c:pt>
                <c:pt idx="11">
                  <c:v>0.0105181060606061</c:v>
                </c:pt>
                <c:pt idx="12">
                  <c:v>0.100640486111111</c:v>
                </c:pt>
                <c:pt idx="13">
                  <c:v>0.106976111111111</c:v>
                </c:pt>
                <c:pt idx="14">
                  <c:v>0.088908947368421</c:v>
                </c:pt>
                <c:pt idx="15">
                  <c:v>0.135920196078431</c:v>
                </c:pt>
                <c:pt idx="16">
                  <c:v>0.0879075757575758</c:v>
                </c:pt>
                <c:pt idx="17">
                  <c:v>0.005831</c:v>
                </c:pt>
                <c:pt idx="18">
                  <c:v>0.0808985833333333</c:v>
                </c:pt>
                <c:pt idx="19">
                  <c:v>0.155035</c:v>
                </c:pt>
                <c:pt idx="20">
                  <c:v>0.100693484848485</c:v>
                </c:pt>
                <c:pt idx="21">
                  <c:v>0.0957038541666666</c:v>
                </c:pt>
                <c:pt idx="22">
                  <c:v>0.186113333333333</c:v>
                </c:pt>
                <c:pt idx="23">
                  <c:v>0.130816304347826</c:v>
                </c:pt>
                <c:pt idx="24">
                  <c:v>0.168182063492063</c:v>
                </c:pt>
              </c:numCache>
            </c:numRef>
          </c:val>
        </c:ser>
        <c:ser>
          <c:idx val="2"/>
          <c:order val="2"/>
          <c:tx>
            <c:strRef>
              <c:f>MBON_26Jun15!$D$1</c:f>
              <c:strCache>
                <c:ptCount val="1"/>
                <c:pt idx="0">
                  <c:v>test</c:v>
                </c:pt>
              </c:strCache>
            </c:strRef>
          </c:tx>
          <c:spPr>
            <a:solidFill>
              <a:srgbClr val="FFFF00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BON_26Jun15!$H$2:$H$26</c:f>
                <c:numCache>
                  <c:formatCode>General</c:formatCode>
                  <c:ptCount val="25"/>
                  <c:pt idx="0">
                    <c:v>0.0718194344111215</c:v>
                  </c:pt>
                  <c:pt idx="1">
                    <c:v>0.0771913186200179</c:v>
                  </c:pt>
                  <c:pt idx="2">
                    <c:v>0.0659524419418536</c:v>
                  </c:pt>
                  <c:pt idx="3">
                    <c:v>0.0822700961127063</c:v>
                  </c:pt>
                  <c:pt idx="4">
                    <c:v>0.084635765272632</c:v>
                  </c:pt>
                  <c:pt idx="5">
                    <c:v>0.0672806657154662</c:v>
                  </c:pt>
                  <c:pt idx="6">
                    <c:v>0.132772640150197</c:v>
                  </c:pt>
                  <c:pt idx="7">
                    <c:v>0.0830500570218654</c:v>
                  </c:pt>
                  <c:pt idx="8">
                    <c:v>0.088482454340932</c:v>
                  </c:pt>
                  <c:pt idx="9">
                    <c:v>0.0995121025620906</c:v>
                  </c:pt>
                  <c:pt idx="10">
                    <c:v>0.0777794457526255</c:v>
                  </c:pt>
                  <c:pt idx="11">
                    <c:v>0.0848393655605578</c:v>
                  </c:pt>
                  <c:pt idx="12">
                    <c:v>0.0751069375488026</c:v>
                  </c:pt>
                  <c:pt idx="13">
                    <c:v>0.0574314212451845</c:v>
                  </c:pt>
                  <c:pt idx="14">
                    <c:v>0.0696120439159269</c:v>
                  </c:pt>
                  <c:pt idx="15">
                    <c:v>0.101513168704732</c:v>
                  </c:pt>
                  <c:pt idx="16">
                    <c:v>0.0769536399094532</c:v>
                  </c:pt>
                  <c:pt idx="17">
                    <c:v>0.130844231144916</c:v>
                  </c:pt>
                  <c:pt idx="18">
                    <c:v>0.0259422385359375</c:v>
                  </c:pt>
                  <c:pt idx="19">
                    <c:v>0.0850486023636773</c:v>
                  </c:pt>
                  <c:pt idx="20">
                    <c:v>0.071911092005989</c:v>
                  </c:pt>
                  <c:pt idx="21">
                    <c:v>0.0761799108268385</c:v>
                  </c:pt>
                  <c:pt idx="22">
                    <c:v>0.0658099913474174</c:v>
                  </c:pt>
                  <c:pt idx="23">
                    <c:v>0.0777749887850766</c:v>
                  </c:pt>
                  <c:pt idx="24">
                    <c:v>0.06589520315012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MBON_26Jun15!$A$2:$A$26</c:f>
              <c:strCache>
                <c:ptCount val="25"/>
                <c:pt idx="0">
                  <c:v>MB051B</c:v>
                </c:pt>
                <c:pt idx="1">
                  <c:v>MB077B</c:v>
                </c:pt>
                <c:pt idx="2">
                  <c:v>MB018B</c:v>
                </c:pt>
                <c:pt idx="3">
                  <c:v>MB011B</c:v>
                </c:pt>
                <c:pt idx="4">
                  <c:v>MB210B</c:v>
                </c:pt>
                <c:pt idx="5">
                  <c:v>MB002B</c:v>
                </c:pt>
                <c:pt idx="6">
                  <c:v>MB083C</c:v>
                </c:pt>
                <c:pt idx="7">
                  <c:v>MB310C</c:v>
                </c:pt>
                <c:pt idx="8">
                  <c:v>MB057B</c:v>
                </c:pt>
                <c:pt idx="9">
                  <c:v>MB549C</c:v>
                </c:pt>
                <c:pt idx="10">
                  <c:v>MB543B</c:v>
                </c:pt>
                <c:pt idx="11">
                  <c:v>MB027B</c:v>
                </c:pt>
                <c:pt idx="12">
                  <c:v>MB242A</c:v>
                </c:pt>
                <c:pt idx="13">
                  <c:v>MB093C</c:v>
                </c:pt>
                <c:pt idx="14">
                  <c:v>MB082C</c:v>
                </c:pt>
                <c:pt idx="15">
                  <c:v>MB074C</c:v>
                </c:pt>
                <c:pt idx="16">
                  <c:v>MB399B</c:v>
                </c:pt>
                <c:pt idx="17">
                  <c:v>MB080C</c:v>
                </c:pt>
                <c:pt idx="18">
                  <c:v>MB052B</c:v>
                </c:pt>
                <c:pt idx="19">
                  <c:v>MB050B</c:v>
                </c:pt>
                <c:pt idx="20">
                  <c:v>MB542B</c:v>
                </c:pt>
                <c:pt idx="21">
                  <c:v>MB112C</c:v>
                </c:pt>
                <c:pt idx="22">
                  <c:v>MB298B</c:v>
                </c:pt>
                <c:pt idx="23">
                  <c:v>MB434B</c:v>
                </c:pt>
                <c:pt idx="24">
                  <c:v>MB433B</c:v>
                </c:pt>
              </c:strCache>
            </c:strRef>
          </c:cat>
          <c:val>
            <c:numRef>
              <c:f>MBON_26Jun15!$D$2:$D$26</c:f>
              <c:numCache>
                <c:formatCode>General</c:formatCode>
                <c:ptCount val="25"/>
                <c:pt idx="0">
                  <c:v>0.302259130434783</c:v>
                </c:pt>
                <c:pt idx="1">
                  <c:v>0.326233484848485</c:v>
                </c:pt>
                <c:pt idx="2">
                  <c:v>0.183975333333333</c:v>
                </c:pt>
                <c:pt idx="3">
                  <c:v>0.44725</c:v>
                </c:pt>
                <c:pt idx="4">
                  <c:v>0.44593652173913</c:v>
                </c:pt>
                <c:pt idx="5">
                  <c:v>0.298708188405797</c:v>
                </c:pt>
                <c:pt idx="6">
                  <c:v>0.29928</c:v>
                </c:pt>
                <c:pt idx="7">
                  <c:v>0.258924555555556</c:v>
                </c:pt>
                <c:pt idx="8">
                  <c:v>0.406843863636364</c:v>
                </c:pt>
                <c:pt idx="9">
                  <c:v>0.500981333333333</c:v>
                </c:pt>
                <c:pt idx="10">
                  <c:v>0.287899318181818</c:v>
                </c:pt>
                <c:pt idx="11">
                  <c:v>0.38529946969697</c:v>
                </c:pt>
                <c:pt idx="12">
                  <c:v>0.310819930555556</c:v>
                </c:pt>
                <c:pt idx="13">
                  <c:v>0.280465555555555</c:v>
                </c:pt>
                <c:pt idx="14">
                  <c:v>0.199428157894737</c:v>
                </c:pt>
                <c:pt idx="15">
                  <c:v>0.303579901960784</c:v>
                </c:pt>
                <c:pt idx="16">
                  <c:v>0.278351893939394</c:v>
                </c:pt>
                <c:pt idx="17">
                  <c:v>0.3548675</c:v>
                </c:pt>
                <c:pt idx="18">
                  <c:v>0.0658650833333333</c:v>
                </c:pt>
                <c:pt idx="19">
                  <c:v>0.166906025641026</c:v>
                </c:pt>
                <c:pt idx="20">
                  <c:v>0.205720606060606</c:v>
                </c:pt>
                <c:pt idx="21">
                  <c:v>0.238079791666667</c:v>
                </c:pt>
                <c:pt idx="22">
                  <c:v>0.227181176470588</c:v>
                </c:pt>
                <c:pt idx="23">
                  <c:v>0.525043623188406</c:v>
                </c:pt>
                <c:pt idx="24">
                  <c:v>0.2294508730158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4190968"/>
        <c:axId val="-2118703752"/>
      </c:barChart>
      <c:catAx>
        <c:axId val="-2114190968"/>
        <c:scaling>
          <c:orientation val="minMax"/>
        </c:scaling>
        <c:delete val="0"/>
        <c:axPos val="b"/>
        <c:majorTickMark val="out"/>
        <c:minorTickMark val="none"/>
        <c:tickLblPos val="nextTo"/>
        <c:crossAx val="-2118703752"/>
        <c:crosses val="autoZero"/>
        <c:auto val="1"/>
        <c:lblAlgn val="ctr"/>
        <c:lblOffset val="100"/>
        <c:noMultiLvlLbl val="0"/>
      </c:catAx>
      <c:valAx>
        <c:axId val="-211870375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ourtship index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1419096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85218926100058"/>
          <c:y val="0.0571846238735124"/>
          <c:w val="0.0952919964573044"/>
          <c:h val="0.27468974586247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340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8117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92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331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5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331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872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980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089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306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363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459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2" name="Chart 1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30399259"/>
              </p:ext>
            </p:extLst>
          </p:nvPr>
        </p:nvGraphicFramePr>
        <p:xfrm>
          <a:off x="784542" y="3601029"/>
          <a:ext cx="5519275" cy="27879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9" name="Chart 1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90766909"/>
              </p:ext>
            </p:extLst>
          </p:nvPr>
        </p:nvGraphicFramePr>
        <p:xfrm>
          <a:off x="776952" y="770461"/>
          <a:ext cx="5526865" cy="27855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395899" y="241534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Figure S5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99135" y="62194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A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99135" y="3468210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B</a:t>
            </a:r>
          </a:p>
        </p:txBody>
      </p:sp>
      <p:sp>
        <p:nvSpPr>
          <p:cNvPr id="9" name="Right Bracket 8"/>
          <p:cNvSpPr/>
          <p:nvPr/>
        </p:nvSpPr>
        <p:spPr>
          <a:xfrm>
            <a:off x="1501955" y="2250227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0" name="Right Bracket 9"/>
          <p:cNvSpPr/>
          <p:nvPr/>
        </p:nvSpPr>
        <p:spPr>
          <a:xfrm>
            <a:off x="1696407" y="2111606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1" name="Right Bracket 10"/>
          <p:cNvSpPr/>
          <p:nvPr/>
        </p:nvSpPr>
        <p:spPr>
          <a:xfrm>
            <a:off x="1545565" y="1811235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2" name="Right Bracket 11"/>
          <p:cNvSpPr/>
          <p:nvPr/>
        </p:nvSpPr>
        <p:spPr>
          <a:xfrm>
            <a:off x="1738591" y="1725083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3" name="Right Bracket 12"/>
          <p:cNvSpPr/>
          <p:nvPr/>
        </p:nvSpPr>
        <p:spPr>
          <a:xfrm>
            <a:off x="3230183" y="2334951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4" name="Right Bracket 13"/>
          <p:cNvSpPr/>
          <p:nvPr/>
        </p:nvSpPr>
        <p:spPr>
          <a:xfrm>
            <a:off x="1884769" y="2205107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5" name="Right Bracket 14"/>
          <p:cNvSpPr/>
          <p:nvPr/>
        </p:nvSpPr>
        <p:spPr>
          <a:xfrm>
            <a:off x="1942818" y="2170893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6" name="Right Bracket 15"/>
          <p:cNvSpPr/>
          <p:nvPr/>
        </p:nvSpPr>
        <p:spPr>
          <a:xfrm>
            <a:off x="2655794" y="2159181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7" name="Right Bracket 16"/>
          <p:cNvSpPr/>
          <p:nvPr/>
        </p:nvSpPr>
        <p:spPr>
          <a:xfrm>
            <a:off x="2697588" y="1641743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8" name="Right Bracket 17"/>
          <p:cNvSpPr/>
          <p:nvPr/>
        </p:nvSpPr>
        <p:spPr>
          <a:xfrm>
            <a:off x="3037977" y="1855885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9" name="Right Bracket 18"/>
          <p:cNvSpPr/>
          <p:nvPr/>
        </p:nvSpPr>
        <p:spPr>
          <a:xfrm>
            <a:off x="3463567" y="1835251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0" name="Right Bracket 19"/>
          <p:cNvSpPr/>
          <p:nvPr/>
        </p:nvSpPr>
        <p:spPr>
          <a:xfrm>
            <a:off x="2464487" y="2370976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1" name="Right Bracket 20"/>
          <p:cNvSpPr/>
          <p:nvPr/>
        </p:nvSpPr>
        <p:spPr>
          <a:xfrm>
            <a:off x="2273939" y="1646895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2" name="Right Bracket 21"/>
          <p:cNvSpPr/>
          <p:nvPr/>
        </p:nvSpPr>
        <p:spPr>
          <a:xfrm>
            <a:off x="2503346" y="1836131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3" name="Right Bracket 22"/>
          <p:cNvSpPr/>
          <p:nvPr/>
        </p:nvSpPr>
        <p:spPr>
          <a:xfrm>
            <a:off x="3080167" y="1456031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4" name="Right Bracket 23"/>
          <p:cNvSpPr/>
          <p:nvPr/>
        </p:nvSpPr>
        <p:spPr>
          <a:xfrm>
            <a:off x="4570774" y="1741644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5" name="Right Bracket 24"/>
          <p:cNvSpPr/>
          <p:nvPr/>
        </p:nvSpPr>
        <p:spPr>
          <a:xfrm>
            <a:off x="2082068" y="1043786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6" name="Right Bracket 25"/>
          <p:cNvSpPr/>
          <p:nvPr/>
        </p:nvSpPr>
        <p:spPr>
          <a:xfrm>
            <a:off x="3272954" y="1156307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7" name="Right Bracket 26"/>
          <p:cNvSpPr/>
          <p:nvPr/>
        </p:nvSpPr>
        <p:spPr>
          <a:xfrm>
            <a:off x="4953631" y="1860700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8" name="Right Bracket 27"/>
          <p:cNvSpPr/>
          <p:nvPr/>
        </p:nvSpPr>
        <p:spPr>
          <a:xfrm>
            <a:off x="2126550" y="1359569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9" name="Right Bracket 28"/>
          <p:cNvSpPr/>
          <p:nvPr/>
        </p:nvSpPr>
        <p:spPr>
          <a:xfrm>
            <a:off x="5534576" y="1970768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0" name="Right Bracket 29"/>
          <p:cNvSpPr/>
          <p:nvPr/>
        </p:nvSpPr>
        <p:spPr>
          <a:xfrm>
            <a:off x="3418938" y="2158170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1" name="Right Bracket 30"/>
          <p:cNvSpPr/>
          <p:nvPr/>
        </p:nvSpPr>
        <p:spPr>
          <a:xfrm>
            <a:off x="5335652" y="2256571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2" name="Right Bracket 31"/>
          <p:cNvSpPr/>
          <p:nvPr/>
        </p:nvSpPr>
        <p:spPr>
          <a:xfrm>
            <a:off x="4187198" y="2173764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3" name="Right Bracket 32"/>
          <p:cNvSpPr/>
          <p:nvPr/>
        </p:nvSpPr>
        <p:spPr>
          <a:xfrm>
            <a:off x="4379380" y="1621525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4" name="Right Bracket 33"/>
          <p:cNvSpPr/>
          <p:nvPr/>
        </p:nvSpPr>
        <p:spPr>
          <a:xfrm>
            <a:off x="3995915" y="1919896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5" name="Right Bracket 34"/>
          <p:cNvSpPr/>
          <p:nvPr/>
        </p:nvSpPr>
        <p:spPr>
          <a:xfrm>
            <a:off x="5145943" y="1960338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6" name="Right Bracket 35"/>
          <p:cNvSpPr/>
          <p:nvPr/>
        </p:nvSpPr>
        <p:spPr>
          <a:xfrm>
            <a:off x="4761618" y="2496091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7" name="Right Bracket 36"/>
          <p:cNvSpPr/>
          <p:nvPr/>
        </p:nvSpPr>
        <p:spPr>
          <a:xfrm>
            <a:off x="4803281" y="1484371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8" name="Right Bracket 37"/>
          <p:cNvSpPr/>
          <p:nvPr/>
        </p:nvSpPr>
        <p:spPr>
          <a:xfrm>
            <a:off x="5954332" y="1149005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9" name="Right Bracket 38"/>
          <p:cNvSpPr/>
          <p:nvPr/>
        </p:nvSpPr>
        <p:spPr>
          <a:xfrm>
            <a:off x="6107380" y="1817320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40" name="Right Bracket 39"/>
          <p:cNvSpPr/>
          <p:nvPr/>
        </p:nvSpPr>
        <p:spPr>
          <a:xfrm>
            <a:off x="3613493" y="1861294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41" name="Right Bracket 40"/>
          <p:cNvSpPr/>
          <p:nvPr/>
        </p:nvSpPr>
        <p:spPr>
          <a:xfrm>
            <a:off x="3656855" y="1532644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42" name="Right Bracket 41"/>
          <p:cNvSpPr/>
          <p:nvPr/>
        </p:nvSpPr>
        <p:spPr>
          <a:xfrm>
            <a:off x="3807075" y="1695173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43" name="Right Bracket 42"/>
          <p:cNvSpPr/>
          <p:nvPr/>
        </p:nvSpPr>
        <p:spPr>
          <a:xfrm>
            <a:off x="3853644" y="1773812"/>
            <a:ext cx="18288" cy="3657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348376" y="2118782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539608" y="1980408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1394881" y="1680102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1588457" y="1593950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3079028" y="2202097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735285" y="2070717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1791663" y="2038039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2503640" y="2024529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544919" y="1506523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2871266" y="1723421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3315091" y="1702787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2312804" y="2241719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354874" y="1711827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2931695" y="1327420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2122793" y="1519155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4419095" y="1616240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929382" y="918382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3122538" y="1030021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4803215" y="1734414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1976134" y="1233283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5377746" y="1844482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3266967" y="2031715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5186753" y="2130284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4037051" y="2046743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4229098" y="1497011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3845633" y="1792175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4995661" y="1832617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4613536" y="2374691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4652999" y="1363614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5804050" y="1024491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5956696" y="1689608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3443567" y="1736789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3656271" y="1579222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3505589" y="1406941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3707121" y="1665680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7" name="Right Bracket 6"/>
          <p:cNvSpPr/>
          <p:nvPr/>
        </p:nvSpPr>
        <p:spPr>
          <a:xfrm>
            <a:off x="1576353" y="5180925"/>
            <a:ext cx="45719" cy="9144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474376" y="5433060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79" name="Right Bracket 78"/>
          <p:cNvSpPr/>
          <p:nvPr/>
        </p:nvSpPr>
        <p:spPr>
          <a:xfrm>
            <a:off x="1670361" y="4926954"/>
            <a:ext cx="45719" cy="9144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80" name="Right Bracket 79"/>
          <p:cNvSpPr/>
          <p:nvPr/>
        </p:nvSpPr>
        <p:spPr>
          <a:xfrm>
            <a:off x="1976931" y="5408339"/>
            <a:ext cx="45719" cy="9144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81" name="Right Bracket 80"/>
          <p:cNvSpPr/>
          <p:nvPr/>
        </p:nvSpPr>
        <p:spPr>
          <a:xfrm>
            <a:off x="2070939" y="5224985"/>
            <a:ext cx="45719" cy="9144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82" name="Right Bracket 81"/>
          <p:cNvSpPr/>
          <p:nvPr/>
        </p:nvSpPr>
        <p:spPr>
          <a:xfrm>
            <a:off x="4397470" y="5354050"/>
            <a:ext cx="45719" cy="9144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83" name="Right Bracket 82"/>
          <p:cNvSpPr/>
          <p:nvPr/>
        </p:nvSpPr>
        <p:spPr>
          <a:xfrm>
            <a:off x="4492843" y="5557543"/>
            <a:ext cx="45719" cy="9144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84" name="Right Bracket 83"/>
          <p:cNvSpPr/>
          <p:nvPr/>
        </p:nvSpPr>
        <p:spPr>
          <a:xfrm>
            <a:off x="4797600" y="5217954"/>
            <a:ext cx="45719" cy="9144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85" name="Right Bracket 84"/>
          <p:cNvSpPr/>
          <p:nvPr/>
        </p:nvSpPr>
        <p:spPr>
          <a:xfrm>
            <a:off x="4897272" y="5089074"/>
            <a:ext cx="45719" cy="9144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86" name="Right Bracket 85"/>
          <p:cNvSpPr/>
          <p:nvPr/>
        </p:nvSpPr>
        <p:spPr>
          <a:xfrm>
            <a:off x="3184101" y="4221809"/>
            <a:ext cx="45719" cy="9144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87" name="Right Bracket 86"/>
          <p:cNvSpPr/>
          <p:nvPr/>
        </p:nvSpPr>
        <p:spPr>
          <a:xfrm>
            <a:off x="3286388" y="3957429"/>
            <a:ext cx="45719" cy="9144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88" name="Right Bracket 87"/>
          <p:cNvSpPr/>
          <p:nvPr/>
        </p:nvSpPr>
        <p:spPr>
          <a:xfrm>
            <a:off x="3594160" y="4674475"/>
            <a:ext cx="45719" cy="9144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89" name="Right Bracket 88"/>
          <p:cNvSpPr/>
          <p:nvPr/>
        </p:nvSpPr>
        <p:spPr>
          <a:xfrm>
            <a:off x="3693481" y="4034781"/>
            <a:ext cx="45719" cy="9144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90" name="Right Bracket 89"/>
          <p:cNvSpPr/>
          <p:nvPr/>
        </p:nvSpPr>
        <p:spPr>
          <a:xfrm>
            <a:off x="5609215" y="5542946"/>
            <a:ext cx="45719" cy="9144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91" name="Right Bracket 90"/>
          <p:cNvSpPr/>
          <p:nvPr/>
        </p:nvSpPr>
        <p:spPr>
          <a:xfrm>
            <a:off x="5707916" y="3997956"/>
            <a:ext cx="45719" cy="9144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92" name="Right Bracket 91"/>
          <p:cNvSpPr/>
          <p:nvPr/>
        </p:nvSpPr>
        <p:spPr>
          <a:xfrm>
            <a:off x="6101067" y="4059701"/>
            <a:ext cx="45719" cy="9144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93" name="Right Bracket 92"/>
          <p:cNvSpPr/>
          <p:nvPr/>
        </p:nvSpPr>
        <p:spPr>
          <a:xfrm>
            <a:off x="6003507" y="4951544"/>
            <a:ext cx="45719" cy="9144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1440486" y="5077053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1533302" y="4823662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1842892" y="5305580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1933776" y="5115170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4256061" y="5254438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4661547" y="5116062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4360127" y="5450788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4760845" y="4983528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3045500" y="4114204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3150875" y="3848972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3556361" y="3925823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3459900" y="4565084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5572332" y="3889354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5964410" y="3949459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5864966" y="4842942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1620076" y="4030361"/>
            <a:ext cx="59510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end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1620076" y="4251859"/>
            <a:ext cx="59510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test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1620076" y="3805774"/>
            <a:ext cx="60467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begin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5273908" y="919566"/>
            <a:ext cx="60467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begin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5273908" y="1175691"/>
            <a:ext cx="534041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end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5273909" y="1424875"/>
            <a:ext cx="51130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test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2906029" y="695818"/>
            <a:ext cx="10569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/>
                <a:cs typeface="Arial"/>
              </a:rPr>
              <a:t>MBON Lines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2512996" y="3571892"/>
            <a:ext cx="18389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/>
                <a:cs typeface="Arial"/>
              </a:rPr>
              <a:t>MBON Secondary Lines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23" name="Right Bracket 122"/>
          <p:cNvSpPr/>
          <p:nvPr/>
        </p:nvSpPr>
        <p:spPr>
          <a:xfrm>
            <a:off x="2393020" y="5183533"/>
            <a:ext cx="45719" cy="9144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2254419" y="5075928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125" name="Right Bracket 124"/>
          <p:cNvSpPr/>
          <p:nvPr/>
        </p:nvSpPr>
        <p:spPr>
          <a:xfrm>
            <a:off x="2471155" y="4322704"/>
            <a:ext cx="45719" cy="9144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2332554" y="4215099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6673967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38</Words>
  <Application>Microsoft Macintosh PowerPoint</Application>
  <PresentationFormat>Letter Paper (8.5x11 in)</PresentationFormat>
  <Paragraphs>6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lby Montague</dc:creator>
  <cp:lastModifiedBy>Shelby Montague</cp:lastModifiedBy>
  <cp:revision>4</cp:revision>
  <dcterms:created xsi:type="dcterms:W3CDTF">2016-09-29T23:23:19Z</dcterms:created>
  <dcterms:modified xsi:type="dcterms:W3CDTF">2016-09-29T23:24:47Z</dcterms:modified>
</cp:coreProperties>
</file>